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37"/>
    <p:restoredTop sz="94712"/>
  </p:normalViewPr>
  <p:slideViewPr>
    <p:cSldViewPr snapToGrid="0">
      <p:cViewPr varScale="1">
        <p:scale>
          <a:sx n="120" d="100"/>
          <a:sy n="120" d="100"/>
        </p:scale>
        <p:origin x="496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483DA00-9D33-921B-89D5-FB6DB1E5E32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2D1F4D0-D700-EEE1-0358-5BBE4A4C2B9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DC5E3DD-104C-CB09-C7A7-BC33EE2153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D8EFB-7E44-D940-8282-2D70F89518A2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62D66D-3F1E-3BC8-A0E2-4710E9F9FDC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63E07A2-B5DA-B313-8AC4-5BBD234A3A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52241-7F22-2F4D-A6AB-931A1B4BE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74316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DA97E6-B0A0-84A3-5BB5-C99BADCC89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C77457-07DA-11EC-591A-94AAA8721AF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2A8B54F-D0C5-0F68-1170-62F5A84C55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D8EFB-7E44-D940-8282-2D70F89518A2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DC62FAB-7F52-AC91-913E-0165B9B051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CDD6FA-83EC-DC83-BC41-8C6372874F9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52241-7F22-2F4D-A6AB-931A1B4BE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5861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4277FCE6-10D8-8468-8889-49591B1483D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147031-9231-79AE-3F8B-98EC0BDD120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338C31-D11A-4220-B65C-67DB311737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D8EFB-7E44-D940-8282-2D70F89518A2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69902DB-4772-5D8D-48DD-7579F7D846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B1983B-A9BF-4417-E771-1B054FADBF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52241-7F22-2F4D-A6AB-931A1B4BE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1843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02DE00-38FB-2437-1654-6E428C3FC9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172C6B-F6FA-7EE0-BC63-3AB0A08FED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F11BCA-9057-FD5D-D3CD-0005D05C3C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D8EFB-7E44-D940-8282-2D70F89518A2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2024173-BEEB-5198-3AB8-7F3CD7FD7A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49115C-E807-1CCA-DADE-7044FA769C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52241-7F22-2F4D-A6AB-931A1B4BE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158577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A034B5D-ED2D-AB00-1963-65454DB4A4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0A82035-3F6E-CC0D-3AED-2D6B9C0E3EF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9FF047-59A9-317E-6D4F-EA2E05416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D8EFB-7E44-D940-8282-2D70F89518A2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082AF4-7D40-1171-5630-4F2C09AD0B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F60D536-2157-B6F9-3FD8-BA61D35601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52241-7F22-2F4D-A6AB-931A1B4BE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48442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2E372B1-00C4-8826-C42C-CA3479CA425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C9D6B6-6FB3-6761-DB81-9C6130D8A78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4AFE81D-E531-435F-50D5-35FC7A9ACE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7006966-64BD-08D4-17AF-6E437F94D2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D8EFB-7E44-D940-8282-2D70F89518A2}" type="datetimeFigureOut">
              <a:rPr lang="en-US" smtClean="0"/>
              <a:t>2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7A95D21-DFB1-87D2-319B-FEACBF73A2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D5947E-9556-549E-7546-A6CC3539EA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52241-7F22-2F4D-A6AB-931A1B4BE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7806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EA668-B374-10D3-BF35-9B8C1BBE9E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B0ED50-52A6-2051-958C-FD3C2BCB8B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B7AB85D-9C64-D52F-754B-77911C954D1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7ECFF87-BE98-68A8-5621-E5C4A33661B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BE6EDAD-328E-1683-7BD9-D24AC3E0F43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6780058-A705-D9AB-9D2C-6ECD07EAF1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D8EFB-7E44-D940-8282-2D70F89518A2}" type="datetimeFigureOut">
              <a:rPr lang="en-US" smtClean="0"/>
              <a:t>2/19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C709826-9EAF-B15B-30BF-F35C931F1C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4DC88E0-77B7-76B9-DA7D-42D98B9A23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52241-7F22-2F4D-A6AB-931A1B4BE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1438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572171-2A0E-2A99-3383-C5A46245B8D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690CD939-9BD9-0827-2F28-AD462EF7F7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D8EFB-7E44-D940-8282-2D70F89518A2}" type="datetimeFigureOut">
              <a:rPr lang="en-US" smtClean="0"/>
              <a:t>2/19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6DC0A7F-09EC-B08B-D3D7-59E6B445EA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C45B0D4-8F38-C2BB-3EF1-BC6BFE1234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52241-7F22-2F4D-A6AB-931A1B4BE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6457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F6CF016-BC58-92A1-9361-4F7C56AF4A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D8EFB-7E44-D940-8282-2D70F89518A2}" type="datetimeFigureOut">
              <a:rPr lang="en-US" smtClean="0"/>
              <a:t>2/19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DA90269-4D2D-123C-CC41-7FE695C68E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53D5064F-4981-2BE4-B0BF-654692FBD2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52241-7F22-2F4D-A6AB-931A1B4BE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05087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82913B-5028-65D4-FDD8-60301214B29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7A45DA-1856-1C0B-6466-ACE4FAF245C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9C2F720-4539-3EFB-E2E0-2AE4AA3E5CF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ED95779-0C27-8CCF-9EEA-5926CDFBC0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D8EFB-7E44-D940-8282-2D70F89518A2}" type="datetimeFigureOut">
              <a:rPr lang="en-US" smtClean="0"/>
              <a:t>2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BD82AA2-1BFB-345B-832D-15F1C448999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0B20C4-3C3A-FD65-3A78-0D5CE1CCFF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52241-7F22-2F4D-A6AB-931A1B4BE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57812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00AFF9F-6E34-C343-FBA3-E8A297C0CB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CCA81EC-9695-169F-BBCB-A43D41FE93B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AE7B24B-C03B-0B99-3B6A-FA9D1FF86D0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A5D8BC4-737F-7CB2-0861-7872CD83F6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ED8EFB-7E44-D940-8282-2D70F89518A2}" type="datetimeFigureOut">
              <a:rPr lang="en-US" smtClean="0"/>
              <a:t>2/19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8F9DA62-ED95-2EF7-5A55-AB2E0FDEE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8B0EC4-4C9A-4562-BF96-F83515CBFA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0552241-7F22-2F4D-A6AB-931A1B4BE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69243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CF65E32-B726-4252-8F02-7DECA29F95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1B3DD94-316F-9FDB-FB46-A42E8F9F5DE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39C6504-BDAA-E100-9EEA-4EEA2B973D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9ED8EFB-7E44-D940-8282-2D70F89518A2}" type="datetimeFigureOut">
              <a:rPr lang="en-US" smtClean="0"/>
              <a:t>2/19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861D7E6-53E1-3224-A3FF-D979C185C2F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75B2098-3DEB-AF07-A3FF-7B5CE4E84CB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0552241-7F22-2F4D-A6AB-931A1B4BEF4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3929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graph of a patient&#10;&#10;Description automatically generated">
            <a:extLst>
              <a:ext uri="{FF2B5EF4-FFF2-40B4-BE49-F238E27FC236}">
                <a16:creationId xmlns:a16="http://schemas.microsoft.com/office/drawing/2014/main" id="{C7610BEB-EBA5-CB72-374D-4B14BA50162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10069" y="298243"/>
            <a:ext cx="7267836" cy="399731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20B96CF6-8C37-5B3B-C37E-71C331773CFE}"/>
              </a:ext>
            </a:extLst>
          </p:cNvPr>
          <p:cNvSpPr txBox="1"/>
          <p:nvPr/>
        </p:nvSpPr>
        <p:spPr>
          <a:xfrm>
            <a:off x="701748" y="4663772"/>
            <a:ext cx="11068493" cy="16749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200000"/>
              </a:lnSpc>
              <a:spcAft>
                <a:spcPts val="800"/>
              </a:spcAft>
            </a:pPr>
            <a:r>
              <a:rPr lang="en-US" sz="18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ry Figure S4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:</a:t>
            </a:r>
            <a:r>
              <a:rPr lang="en-US" sz="1800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orted </a:t>
            </a:r>
            <a:r>
              <a:rPr lang="en-US" sz="1800" dirty="0" err="1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ignaL</a:t>
            </a:r>
            <a:r>
              <a:rPr lang="en-US" sz="18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scores in plasma from 20 subjects with advanced adenomas, 20 subjects with colorectal cancer, and 32 control subjects, after including 20 subjects with advanced adenoma in the training set.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3846718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39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amel Lahouel</dc:creator>
  <cp:lastModifiedBy>Kamel Lahouel</cp:lastModifiedBy>
  <cp:revision>1</cp:revision>
  <dcterms:created xsi:type="dcterms:W3CDTF">2025-02-20T04:52:24Z</dcterms:created>
  <dcterms:modified xsi:type="dcterms:W3CDTF">2025-02-20T04:53:37Z</dcterms:modified>
</cp:coreProperties>
</file>